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139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00"/>
    <a:srgbClr val="FF4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inimized">
    <p:restoredLeft sz="6588" autoAdjust="0"/>
    <p:restoredTop sz="92193" autoAdjust="0"/>
  </p:normalViewPr>
  <p:slideViewPr>
    <p:cSldViewPr snapToGrid="0">
      <p:cViewPr varScale="1">
        <p:scale>
          <a:sx n="70" d="100"/>
          <a:sy n="70" d="100"/>
        </p:scale>
        <p:origin x="2532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FADDFF-79D3-489A-B3FD-8BBEE06090D6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44DEB8-AA87-42D6-A54B-B14D941F1C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92515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68B7-3023-48C0-9DC8-83C85B50F4A8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BC0A5-92C9-49EA-929A-9DF3CD446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5749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68B7-3023-48C0-9DC8-83C85B50F4A8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BC0A5-92C9-49EA-929A-9DF3CD446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67638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68B7-3023-48C0-9DC8-83C85B50F4A8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BC0A5-92C9-49EA-929A-9DF3CD446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2946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68B7-3023-48C0-9DC8-83C85B50F4A8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BC0A5-92C9-49EA-929A-9DF3CD446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56373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68B7-3023-48C0-9DC8-83C85B50F4A8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BC0A5-92C9-49EA-929A-9DF3CD446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27185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68B7-3023-48C0-9DC8-83C85B50F4A8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BC0A5-92C9-49EA-929A-9DF3CD446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1712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68B7-3023-48C0-9DC8-83C85B50F4A8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BC0A5-92C9-49EA-929A-9DF3CD446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4064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68B7-3023-48C0-9DC8-83C85B50F4A8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BC0A5-92C9-49EA-929A-9DF3CD446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9534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68B7-3023-48C0-9DC8-83C85B50F4A8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BC0A5-92C9-49EA-929A-9DF3CD446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0366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68B7-3023-48C0-9DC8-83C85B50F4A8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BC0A5-92C9-49EA-929A-9DF3CD446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84137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 anchor="t"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68B7-3023-48C0-9DC8-83C85B50F4A8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BC0A5-92C9-49EA-929A-9DF3CD446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1227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D568B7-3023-48C0-9DC8-83C85B50F4A8}" type="datetimeFigureOut">
              <a:rPr kumimoji="1" lang="ja-JP" altLang="en-US" smtClean="0"/>
              <a:t>2022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7BC0A5-92C9-49EA-929A-9DF3CD446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76810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kumimoji="1"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8E14030-0DAF-4C38-BB19-8E3C8953F5D5}"/>
              </a:ext>
            </a:extLst>
          </p:cNvPr>
          <p:cNvSpPr txBox="1"/>
          <p:nvPr/>
        </p:nvSpPr>
        <p:spPr>
          <a:xfrm>
            <a:off x="365759" y="184666"/>
            <a:ext cx="2563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ry Table 1</a:t>
            </a:r>
            <a:endParaRPr kumimoji="1" lang="ja-JP" altLang="en-US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1B852E9-1FB2-45BE-94E7-F80479056BD3}"/>
              </a:ext>
            </a:extLst>
          </p:cNvPr>
          <p:cNvSpPr txBox="1"/>
          <p:nvPr/>
        </p:nvSpPr>
        <p:spPr>
          <a:xfrm>
            <a:off x="4921214" y="176046"/>
            <a:ext cx="1619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err="1"/>
              <a:t>Tomida</a:t>
            </a:r>
            <a:r>
              <a:rPr kumimoji="1" lang="en-US" altLang="ja-JP" dirty="0"/>
              <a:t> A. et al.</a:t>
            </a:r>
            <a:endParaRPr kumimoji="1" lang="ja-JP" altLang="en-US" dirty="0"/>
          </a:p>
        </p:txBody>
      </p:sp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CE157286-18B7-4E16-9287-4D113E5A5B7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41506522"/>
              </p:ext>
            </p:extLst>
          </p:nvPr>
        </p:nvGraphicFramePr>
        <p:xfrm>
          <a:off x="882650" y="369332"/>
          <a:ext cx="5092700" cy="3362325"/>
        </p:xfrm>
        <a:graphic>
          <a:graphicData uri="http://schemas.openxmlformats.org/drawingml/2006/table">
            <a:tbl>
              <a:tblPr/>
              <a:tblGrid>
                <a:gridCol w="685800">
                  <a:extLst>
                    <a:ext uri="{9D8B030D-6E8A-4147-A177-3AD203B41FA5}">
                      <a16:colId xmlns:a16="http://schemas.microsoft.com/office/drawing/2014/main" val="2540816693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1406252088"/>
                    </a:ext>
                  </a:extLst>
                </a:gridCol>
                <a:gridCol w="1346200">
                  <a:extLst>
                    <a:ext uri="{9D8B030D-6E8A-4147-A177-3AD203B41FA5}">
                      <a16:colId xmlns:a16="http://schemas.microsoft.com/office/drawing/2014/main" val="2076991341"/>
                    </a:ext>
                  </a:extLst>
                </a:gridCol>
                <a:gridCol w="1104900">
                  <a:extLst>
                    <a:ext uri="{9D8B030D-6E8A-4147-A177-3AD203B41FA5}">
                      <a16:colId xmlns:a16="http://schemas.microsoft.com/office/drawing/2014/main" val="2866233967"/>
                    </a:ext>
                  </a:extLst>
                </a:gridCol>
                <a:gridCol w="584200">
                  <a:extLst>
                    <a:ext uri="{9D8B030D-6E8A-4147-A177-3AD203B41FA5}">
                      <a16:colId xmlns:a16="http://schemas.microsoft.com/office/drawing/2014/main" val="880581349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3791182047"/>
                    </a:ext>
                  </a:extLst>
                </a:gridCol>
              </a:tblGrid>
              <a:tr h="238125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4313477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7867344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Variant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3627172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en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DN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rotei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VA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8823600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SH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.1741del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.I581Lfs*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78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8112660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SH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.1148del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.K383Rfs*3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229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6161650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F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.4819_4820ins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.Y1607Lfs*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62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5430154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ALB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.886del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.M296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15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57584597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RF3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.214G&gt;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.G72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034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786303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B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.220_221insA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.A74Efs*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559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0988046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ET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.1443_1444delG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.N482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14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1954664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P5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.743G&gt;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.R248Q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70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9057552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4334925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232295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61825327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88</TotalTime>
  <Words>96</Words>
  <Application>Microsoft Office PowerPoint</Application>
  <PresentationFormat>A4 210 x 297 mm</PresentationFormat>
  <Paragraphs>4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1_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柳生 茂希</dc:creator>
  <cp:lastModifiedBy>千代延 友裕</cp:lastModifiedBy>
  <cp:revision>150</cp:revision>
  <cp:lastPrinted>2021-11-29T01:49:44Z</cp:lastPrinted>
  <dcterms:created xsi:type="dcterms:W3CDTF">2020-05-14T00:33:08Z</dcterms:created>
  <dcterms:modified xsi:type="dcterms:W3CDTF">2022-01-24T09:17:14Z</dcterms:modified>
</cp:coreProperties>
</file>